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7432000" cy="27432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57E40-4925-4935-87C1-519178ACDA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371600" y="1585728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1A26F-A2E4-40F6-8D24-4D68802203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02236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EDA48-6108-4C14-8BBB-C6AF38781C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971892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066240" y="640044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37160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971892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066240" y="15857280"/>
            <a:ext cx="79495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461B0-9B37-40B3-A81A-44292B2FF1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276"/>
              </a:spcBef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E6D61-67FE-4F5B-B984-348C50426E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A9997-D1B1-4793-91E9-153E264655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BBE48-1A37-4239-A29E-C628BD646B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5F694-8DE8-4287-8ED6-14C5F4022E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371600" y="1098720"/>
            <a:ext cx="24688800" cy="2119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276"/>
              </a:spcBef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17E1C-7389-443F-84CA-CF5525E0C9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46FCC-DFF8-418E-A2DF-4013C4614A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022360" y="1585728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018FA-67BD-460F-98CA-171DAB3D64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37160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022360" y="6400440"/>
            <a:ext cx="1204812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371600" y="15857280"/>
            <a:ext cx="24688800" cy="863604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indent="0">
              <a:spcBef>
                <a:spcPts val="2276"/>
              </a:spcBef>
              <a:buNone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CF03E-F81E-4204-A4E6-C85CD6608E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371600" y="1098720"/>
            <a:ext cx="24688800" cy="457200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ctr">
            <a:noAutofit/>
          </a:bodyPr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1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371600" y="6400440"/>
            <a:ext cx="24688800" cy="1810548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rmAutofit/>
          </a:bodyPr>
          <a:p>
            <a:pPr marL="979560" indent="-979560">
              <a:spcBef>
                <a:spcPts val="2276"/>
              </a:spcBef>
              <a:buClr>
                <a:srgbClr val="000000"/>
              </a:buClr>
              <a:buFont typeface="Arial"/>
              <a:buChar char="•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1" marL="2122560" indent="-816120">
              <a:spcBef>
                <a:spcPts val="2276"/>
              </a:spcBef>
              <a:buClr>
                <a:srgbClr val="000000"/>
              </a:buClr>
              <a:buFont typeface="Arial"/>
              <a:buChar char="–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2" marL="3265560" indent="-652680">
              <a:spcBef>
                <a:spcPts val="2276"/>
              </a:spcBef>
              <a:buClr>
                <a:srgbClr val="000000"/>
              </a:buClr>
              <a:buFont typeface="Arial"/>
              <a:buChar char="•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3" marL="4572000" indent="-654120">
              <a:spcBef>
                <a:spcPts val="2276"/>
              </a:spcBef>
              <a:buClr>
                <a:srgbClr val="000000"/>
              </a:buClr>
              <a:buFont typeface="Arial"/>
              <a:buChar char="–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4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5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  <a:p>
            <a:pPr lvl="6" marL="5878440" indent="-654120">
              <a:spcBef>
                <a:spcPts val="2276"/>
              </a:spcBef>
              <a:buClr>
                <a:srgbClr val="000000"/>
              </a:buClr>
              <a:buFont typeface="Arial"/>
              <a:buChar char="»"/>
              <a:tabLst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9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9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371600" y="24982200"/>
            <a:ext cx="6400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372600" y="24982200"/>
            <a:ext cx="8686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9659600" y="24982200"/>
            <a:ext cx="6400800" cy="1904760"/>
          </a:xfrm>
          <a:prstGeom prst="rect">
            <a:avLst/>
          </a:prstGeom>
          <a:noFill/>
          <a:ln w="0">
            <a:noFill/>
          </a:ln>
        </p:spPr>
        <p:txBody>
          <a:bodyPr lIns="261360" rIns="261360" tIns="130680" bIns="130680" anchor="t">
            <a:noAutofit/>
          </a:bodyPr>
          <a:lstStyle>
            <a:lvl1pPr indent="0" algn="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  <a:defRPr b="0" lang="en-US" sz="4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fld id="{18800F3A-B572-4754-AD1C-ECC559354036}" type="slidenum">
              <a:rPr b="0" lang="en-US" sz="4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27432000" cy="2569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0                            2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H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gaggttcagctgcagcagtctggggcagagcttgtgaagccaggggcctcagtcaagttgtcctgcacagcttctggc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E  V  Q  L  Q  Q  S  G  A  E  L  V  K  P  G  A  S  V  K  L  S  C  T  A  S  G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gaggttcagctgcagcagtctggggcagagctt</a:t>
            </a:r>
            <a:r>
              <a:rPr b="1" lang="en-AU" sz="4000" spc="-1" strike="noStrike">
                <a:solidFill>
                  <a:srgbClr val="ff0066"/>
                </a:solidFill>
                <a:latin typeface="Courier New"/>
              </a:rPr>
              <a:t>c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tgaagccaggggcctcagtcaagtt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c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gca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tctggc</a:t>
            </a:r>
            <a:r>
              <a:rPr b="0" lang="en-AU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E  V  Q  L  Q  Q  S  G  A  E  L  </a:t>
            </a:r>
            <a:r>
              <a:rPr b="1" lang="pt-BR" sz="4000" spc="-1" strike="noStrike">
                <a:solidFill>
                  <a:srgbClr val="ff0066"/>
                </a:solidFill>
                <a:latin typeface="Courier New"/>
              </a:rPr>
              <a:t>L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K  P  G  A  S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V  K  L  S  C  </a:t>
            </a:r>
            <a:r>
              <a:rPr b="1" lang="en-AU" sz="4000" spc="-1" strike="noStrike">
                <a:solidFill>
                  <a:srgbClr val="ff0066"/>
                </a:solidFill>
                <a:latin typeface="Courier New"/>
              </a:rPr>
              <a:t>I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1" lang="en-AU" sz="4000" spc="-1" strike="noStrike">
                <a:solidFill>
                  <a:srgbClr val="ff0066"/>
                </a:solidFill>
                <a:latin typeface="Courier New"/>
              </a:rPr>
              <a:t>V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S  G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73 71  5 16                                                             21 63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30                            40                            50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H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ttcaacattaaagacacctatatgcactgggtgaagcagaggcctgaacagggcctggagtggattggaaggattg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F  N  I  K  D  T  Y  M  H  W  V  K  Q  R  P  E  Q  G  L  E  W  I  G  R  I  D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ttcaa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a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ttaaagacacc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a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tatgcactgggtg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aagcagaggcctgaacagggcctggagtggattggaaggattga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F  </a:t>
            </a:r>
            <a:r>
              <a:rPr b="1" lang="en-AU" sz="4000" spc="-1" strike="noStrike">
                <a:solidFill>
                  <a:srgbClr val="ff0066"/>
                </a:solidFill>
                <a:latin typeface="Courier New"/>
              </a:rPr>
              <a:t>K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I  K  </a:t>
            </a:r>
            <a:r>
              <a:rPr b="1" lang="en-AU" sz="4000" spc="-1" strike="noStrike" u="sng">
                <a:solidFill>
                  <a:srgbClr val="000000"/>
                </a:solidFill>
                <a:uFillTx/>
                <a:latin typeface="Courier New"/>
              </a:rPr>
              <a:t>D  T  </a:t>
            </a:r>
            <a:r>
              <a:rPr b="1" lang="en-AU" sz="4000" spc="-1" strike="noStrike" u="sng">
                <a:solidFill>
                  <a:srgbClr val="ff0066"/>
                </a:solidFill>
                <a:uFillTx/>
                <a:latin typeface="Courier New"/>
              </a:rPr>
              <a:t>S</a:t>
            </a:r>
            <a:r>
              <a:rPr b="1" lang="en-AU" sz="4000" spc="-1" strike="noStrike" u="sng">
                <a:solidFill>
                  <a:srgbClr val="000000"/>
                </a:solidFill>
                <a:uFillTx/>
                <a:latin typeface="Courier New"/>
              </a:rPr>
              <a:t>  M  H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W  V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K  Q  R  P  E  Q  G  L  E  W  I  G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R  I  D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86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85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113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24 23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CDR1                                       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10    17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60                            70       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H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cctgcgaatggtaatactaaatatgacccgaagttccagggcaaggccactataacagcagacacatcctccaacac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P  A  N  G  N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T  K  Y  D  P  K  F  Q  G  K  A  T  I  T  A  D  T  S  S  N  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1F9  cctgcgaatg</a:t>
            </a:r>
            <a:r>
              <a:rPr b="1" lang="pt-BR" sz="4000" spc="-1" strike="noStrike">
                <a:solidFill>
                  <a:srgbClr val="ff0066"/>
                </a:solidFill>
                <a:latin typeface="Courier New"/>
              </a:rPr>
              <a:t>a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taat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t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atatgacccgaagttccagggcaaggccactataacagcagacacatcctccaacac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P  A  N  </a:t>
            </a:r>
            <a:r>
              <a:rPr b="1" lang="en-US" sz="4000" spc="-1" strike="noStrike" u="sng">
                <a:solidFill>
                  <a:srgbClr val="ff0066"/>
                </a:solidFill>
                <a:uFillTx/>
                <a:latin typeface="Courier New"/>
              </a:rPr>
              <a:t>D</a:t>
            </a:r>
            <a:r>
              <a:rPr b="1" lang="en-US" sz="4000" spc="-1" strike="noStrike" u="sng">
                <a:solidFill>
                  <a:srgbClr val="000000"/>
                </a:solidFill>
                <a:uFillTx/>
                <a:latin typeface="Courier New"/>
              </a:rPr>
              <a:t>  N  </a:t>
            </a:r>
            <a:r>
              <a:rPr b="1" lang="en-AU" sz="4000" spc="-1" strike="noStrike" u="sng">
                <a:solidFill>
                  <a:srgbClr val="ff0066"/>
                </a:solidFill>
                <a:uFillTx/>
                <a:latin typeface="Courier New"/>
              </a:rPr>
              <a:t>S</a:t>
            </a:r>
            <a:r>
              <a:rPr b="1" lang="en-AU" sz="4000" spc="-1" strike="noStrike" u="sng">
                <a:solidFill>
                  <a:srgbClr val="000000"/>
                </a:solidFill>
                <a:uFillTx/>
                <a:latin typeface="Courier New"/>
              </a:rPr>
              <a:t>  </a:t>
            </a:r>
            <a:r>
              <a:rPr b="1" lang="en-AU" sz="4000" spc="-1" strike="noStrike" u="sng">
                <a:solidFill>
                  <a:srgbClr val="ff0066"/>
                </a:solidFill>
                <a:uFillTx/>
                <a:latin typeface="Courier New"/>
              </a:rPr>
              <a:t>E</a:t>
            </a:r>
            <a:r>
              <a:rPr b="1" lang="en-AU" sz="4000" spc="-1" strike="noStrike" u="sng">
                <a:solidFill>
                  <a:srgbClr val="000000"/>
                </a:solidFill>
                <a:uFillTx/>
                <a:latin typeface="Courier New"/>
              </a:rPr>
              <a:t>  Y  D  P  K  F  Q  G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K  A  T  I  T  A  D  T  S  S  N  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DR2                                                          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26 10 27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80                           90                           100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H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gcctacctgcagctcagcagcctgacatctgaggacactgccgtctattactgtgct</a:t>
            </a:r>
            <a:r>
              <a:rPr b="1" lang="en-AU" sz="4000" spc="-1" strike="noStrike">
                <a:solidFill>
                  <a:srgbClr val="0000ff"/>
                </a:solidFill>
                <a:latin typeface="Courier New"/>
              </a:rPr>
              <a:t>agaCACAGTGttgcaaccac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AU" sz="4000" spc="-1" strike="noStrike">
                <a:solidFill>
                  <a:srgbClr val="000000"/>
                </a:solidFill>
                <a:latin typeface="Courier New"/>
              </a:rPr>
              <a:t>A  Y  L  Q  L  S  S  L  T  S  E  D  T  A  V  Y  Y  C  A     </a:t>
            </a:r>
            <a:r>
              <a:rPr b="1" lang="en-AU" sz="4000" spc="-1" strike="noStrike">
                <a:solidFill>
                  <a:srgbClr val="0000ff"/>
                </a:solidFill>
                <a:latin typeface="Courier New"/>
              </a:rPr>
              <a:t>7 mer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D?                                                            ctttccc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J2               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GGTTTTTGTacacccactaaaggggtctatgaTAGTGTGactacttt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ctactggggcca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808080"/>
                </a:solidFill>
                <a:latin typeface="Courier New"/>
              </a:rPr>
              <a:t>                   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9 mer                          7 mer       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Y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W  G  Q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1F9  gcctacctgcagctcagcagcctgacatctgaggacactgccgtctattactgt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a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t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ctttcccact</a:t>
            </a:r>
            <a:r>
              <a:rPr b="1" lang="pt-BR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ctggggcca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A  Y  L  Q  L  S  S  L  T  S  E  D  T  A  V  Y  Y  C  </a:t>
            </a:r>
            <a:r>
              <a:rPr b="1" lang="en-US" sz="4000" spc="-1" strike="noStrike">
                <a:solidFill>
                  <a:srgbClr val="ff0066"/>
                </a:solidFill>
                <a:latin typeface="Courier New"/>
              </a:rPr>
              <a:t>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L  </a:t>
            </a:r>
            <a:r>
              <a:rPr b="1" lang="pt-BR" sz="4000" spc="-1" strike="noStrike" u="sng">
                <a:solidFill>
                  <a:srgbClr val="000000"/>
                </a:solidFill>
                <a:uFillTx/>
                <a:latin typeface="Courier New"/>
              </a:rPr>
              <a:t>S  H  </a:t>
            </a:r>
            <a:r>
              <a:rPr b="1" lang="pt-BR" sz="4000" spc="-1" strike="noStrike" u="sng">
                <a:solidFill>
                  <a:srgbClr val="ff0066"/>
                </a:solidFill>
                <a:uFillTx/>
                <a:latin typeface="Courier New"/>
              </a:rPr>
              <a:t>F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W  G  Q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10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35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 </a:t>
            </a:r>
            <a:r>
              <a:rPr b="1" lang="en-US" sz="4000" spc="-1" strike="noStrike" u="sng">
                <a:solidFill>
                  <a:srgbClr val="33cc33"/>
                </a:solidFill>
                <a:uFillTx/>
                <a:latin typeface="Courier New"/>
              </a:rPr>
              <a:t>57</a:t>
            </a:r>
            <a:r>
              <a:rPr b="1" lang="en-US" sz="4000" spc="-1" strike="noStrike">
                <a:solidFill>
                  <a:srgbClr val="33cc33"/>
                </a:solidFill>
                <a:latin typeface="Courier New"/>
              </a:rPr>
              <a:t> 80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CDR3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VH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tcctgagcgtgTCAGAAACC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9 mer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       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110                           120                       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J2   ggcaccactctcacagtctcctcAG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GTGAGTccttaaaa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G  T  T  L  T  V  S  S |</a:t>
            </a:r>
            <a:r>
              <a:rPr b="1" lang="pt-BR" sz="4000" spc="-1" strike="noStrike">
                <a:solidFill>
                  <a:srgbClr val="0000ff"/>
                </a:solidFill>
                <a:latin typeface="Courier New"/>
              </a:rPr>
              <a:t>splice donor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CH1  </a:t>
            </a:r>
            <a:r>
              <a:rPr b="1" lang="pt-BR" sz="4000" spc="-1" strike="noStrike">
                <a:solidFill>
                  <a:srgbClr val="0000ff"/>
                </a:solidFill>
                <a:latin typeface="Courier New"/>
              </a:rPr>
              <a:t>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cacacaTTCTCCTCTCTTGCAG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caaaacaacacccccatcagtctatccactggcccctgggtgtggagatac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                 </a:t>
            </a:r>
            <a:r>
              <a:rPr b="1" lang="en-US" sz="4000" spc="-1" strike="noStrike">
                <a:solidFill>
                  <a:srgbClr val="0000ff"/>
                </a:solidFill>
                <a:latin typeface="Courier New"/>
              </a:rPr>
              <a:t>splice accept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|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K  T  T  P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P  S  V  Y  P  L  A  P  G  C  G  D  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1F9  ggcaccactctcacagtctcctcagccaaaacaacaccc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ccatcagtctatccactggcccctgggtgtggagatac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12880"/>
                <a:tab algn="l" pos="5226120"/>
                <a:tab algn="l" pos="7839000"/>
                <a:tab algn="l" pos="10452240"/>
              </a:tabLst>
            </a:pP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1" lang="pt-BR" sz="4000" spc="-1" strike="noStrike">
                <a:solidFill>
                  <a:srgbClr val="000000"/>
                </a:solidFill>
                <a:latin typeface="Courier New"/>
              </a:rPr>
              <a:t>G  T  T  L  T  V  S  S  A  K  T  T  P</a:t>
            </a:r>
            <a:r>
              <a:rPr b="1" lang="en-US" sz="4000" spc="-1" strike="noStrike">
                <a:solidFill>
                  <a:srgbClr val="000000"/>
                </a:solidFill>
                <a:latin typeface="Courier New"/>
              </a:rPr>
              <a:t>  P  S  V  Y  P  L  A  P  G  C  G  D  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23880" y="18897480"/>
            <a:ext cx="4343400" cy="533520"/>
          </a:xfrm>
          <a:prstGeom prst="rightArrow">
            <a:avLst>
              <a:gd name="adj1" fmla="val 50000"/>
              <a:gd name="adj2" fmla="val 94903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57600" y="3581280"/>
            <a:ext cx="3429000" cy="609840"/>
          </a:xfrm>
          <a:prstGeom prst="rightArrow">
            <a:avLst>
              <a:gd name="adj1" fmla="val 42806"/>
              <a:gd name="adj2" fmla="val 83196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982080" y="3657600"/>
            <a:ext cx="2514600" cy="533520"/>
          </a:xfrm>
          <a:prstGeom prst="rightArrow">
            <a:avLst>
              <a:gd name="adj1" fmla="val 50000"/>
              <a:gd name="adj2" fmla="val 117831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297280" y="3657600"/>
            <a:ext cx="7162920" cy="533520"/>
          </a:xfrm>
          <a:prstGeom prst="rightArrow">
            <a:avLst>
              <a:gd name="adj1" fmla="val 50000"/>
              <a:gd name="adj2" fmla="val 13351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153280" y="8534520"/>
            <a:ext cx="5257800" cy="533160"/>
          </a:xfrm>
          <a:prstGeom prst="rightArrow">
            <a:avLst>
              <a:gd name="adj1" fmla="val 50000"/>
              <a:gd name="adj2" fmla="val 124776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211680" y="8534520"/>
            <a:ext cx="7162920" cy="533160"/>
          </a:xfrm>
          <a:prstGeom prst="rightArrow">
            <a:avLst>
              <a:gd name="adj1" fmla="val 50000"/>
              <a:gd name="adj2" fmla="val 13360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486400" y="12649320"/>
            <a:ext cx="3429000" cy="609480"/>
          </a:xfrm>
          <a:prstGeom prst="rightArrow">
            <a:avLst>
              <a:gd name="adj1" fmla="val 42806"/>
              <a:gd name="adj2" fmla="val 83245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468480" y="12725280"/>
            <a:ext cx="5257800" cy="533520"/>
          </a:xfrm>
          <a:prstGeom prst="rightArrow">
            <a:avLst>
              <a:gd name="adj1" fmla="val 50000"/>
              <a:gd name="adj2" fmla="val 124692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3698080" y="12725280"/>
            <a:ext cx="2514600" cy="533520"/>
          </a:xfrm>
          <a:prstGeom prst="rightArrow">
            <a:avLst>
              <a:gd name="adj1" fmla="val 50000"/>
              <a:gd name="adj2" fmla="val 117831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5450920" y="11353680"/>
            <a:ext cx="914400" cy="1295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33520" y="18745200"/>
            <a:ext cx="1143000" cy="7621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3639680" y="18897480"/>
            <a:ext cx="6019920" cy="533520"/>
          </a:xfrm>
          <a:prstGeom prst="rightArrow">
            <a:avLst>
              <a:gd name="adj1" fmla="val 50000"/>
              <a:gd name="adj2" fmla="val 127931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581280" y="25603200"/>
            <a:ext cx="4343400" cy="533520"/>
          </a:xfrm>
          <a:prstGeom prst="rightArrow">
            <a:avLst>
              <a:gd name="adj1" fmla="val 50000"/>
              <a:gd name="adj2" fmla="val 94903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4554080" y="25679520"/>
            <a:ext cx="4343400" cy="533160"/>
          </a:xfrm>
          <a:prstGeom prst="rightArrow">
            <a:avLst>
              <a:gd name="adj1" fmla="val 50000"/>
              <a:gd name="adj2" fmla="val 949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10972800" y="17068680"/>
            <a:ext cx="380880" cy="4191120"/>
          </a:xfrm>
          <a:prstGeom prst="can">
            <a:avLst>
              <a:gd name="adj" fmla="val 3000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2021920" y="18897480"/>
            <a:ext cx="1447560" cy="533520"/>
          </a:xfrm>
          <a:prstGeom prst="rightArrow">
            <a:avLst>
              <a:gd name="adj1" fmla="val 50000"/>
              <a:gd name="adj2" fmla="val 67831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18T15:26:30Z</dcterms:created>
  <dc:creator>abatchel</dc:creator>
  <dc:description/>
  <dc:language>en-US</dc:language>
  <cp:lastModifiedBy>Daniel Amzel</cp:lastModifiedBy>
  <dcterms:modified xsi:type="dcterms:W3CDTF">2007-05-09T09:54:00Z</dcterms:modified>
  <cp:revision>36</cp:revision>
  <dc:subject/>
  <dc:title>Slide 1</dc:title>
</cp:coreProperties>
</file>